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150" d="100"/>
          <a:sy n="150" d="100"/>
        </p:scale>
        <p:origin x="-150" y="819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AADC-C0E5-487B-8BB3-EF922AECCA6E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FB31B-7B87-498C-9523-EC01277ACC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0808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AADC-C0E5-487B-8BB3-EF922AECCA6E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FB31B-7B87-498C-9523-EC01277ACC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499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AADC-C0E5-487B-8BB3-EF922AECCA6E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FB31B-7B87-498C-9523-EC01277ACC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4810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AADC-C0E5-487B-8BB3-EF922AECCA6E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FB31B-7B87-498C-9523-EC01277ACC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4743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AADC-C0E5-487B-8BB3-EF922AECCA6E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FB31B-7B87-498C-9523-EC01277ACC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8443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AADC-C0E5-487B-8BB3-EF922AECCA6E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FB31B-7B87-498C-9523-EC01277ACC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997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AADC-C0E5-487B-8BB3-EF922AECCA6E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FB31B-7B87-498C-9523-EC01277ACC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3330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AADC-C0E5-487B-8BB3-EF922AECCA6E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FB31B-7B87-498C-9523-EC01277ACC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991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AADC-C0E5-487B-8BB3-EF922AECCA6E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FB31B-7B87-498C-9523-EC01277ACC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2195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AADC-C0E5-487B-8BB3-EF922AECCA6E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FB31B-7B87-498C-9523-EC01277ACC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4721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AADC-C0E5-487B-8BB3-EF922AECCA6E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FB31B-7B87-498C-9523-EC01277ACC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97303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58AADC-C0E5-487B-8BB3-EF922AECCA6E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2FB31B-7B87-498C-9523-EC01277ACC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6990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7097956"/>
              </p:ext>
            </p:extLst>
          </p:nvPr>
        </p:nvGraphicFramePr>
        <p:xfrm>
          <a:off x="304800" y="1652337"/>
          <a:ext cx="6049629" cy="7865431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693756"/>
                <a:gridCol w="1219758"/>
                <a:gridCol w="1654815"/>
                <a:gridCol w="1240650"/>
                <a:gridCol w="1240650"/>
              </a:tblGrid>
              <a:tr h="36160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tle/Abstract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reening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ll Text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reening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</a:tr>
              <a:tr h="36160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lusion criteria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clusion criteria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lusion criteria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clusion criteria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</a:tr>
              <a:tr h="89453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man studies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50 cases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studies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0 cases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10 cases for metformin group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iews, editorial comments, meeting abstracts, book chapters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peer review articles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man studies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gt;50 cases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ised controlled studies and prospective randomised controlled studies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studies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0 cases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iews, editorial comments, meeting abstracts, book chapters, non-peer review articles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</a:tr>
              <a:tr h="88049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gnant women with GDM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marL="228600"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men with diagnosed GDM with singleton pregnancies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ese, non-diabetic pregnant women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clusion of participants based on fetal/birth weight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</a:tr>
              <a:tr h="119271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osure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formin vs. insulin AND/OR diet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228600"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vention given prior to pregnancy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pharmacological interventions, including glyburide, </a:t>
                      </a:r>
                      <a:r>
                        <a:rPr lang="en-GB" sz="8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ibenclamide</a:t>
                      </a: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GB" sz="8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</a:t>
                      </a: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inositol.                                                            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formin compared with insulin and/or diet therapy for women with GDM or untreated women with GDM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vention given only during pregnancy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457200"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marL="457200"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</a:tr>
              <a:tr h="417449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come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‘Baseline’ maternal parameters recorded before study start and/or at follow-up 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rth weight and/or growth parameters of neonate recorded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gnancy and delivery complications recorded (e.g. gestational hypertension, pre-eclampsia and preterm birth) 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onatal outcomes (including </a:t>
                      </a:r>
                      <a:r>
                        <a:rPr lang="en-GB" sz="8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erglycemia</a:t>
                      </a: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birth weight, SGA, LGA and body composition measurements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ldhood body composition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ldhood metabolic measures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marL="457200"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ternal parameters recorded before study start and/or after study/follow-up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rth weight and/or growth parameters of neonate recorded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gnancy and delivery complications recorded (e.g. gestational hypertension, pre-eclampsia and preterm birth)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onatal outcomes recorded (including </a:t>
                      </a:r>
                      <a:r>
                        <a:rPr lang="en-GB" sz="8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erglycemia</a:t>
                      </a: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birth weight, SGA, LGA and body composition)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457200"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39404" y="10266947"/>
            <a:ext cx="24545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Table: </a:t>
            </a:r>
            <a:r>
              <a:rPr lang="nl-NL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/Exclusion </a:t>
            </a:r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iteria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3143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3</TotalTime>
  <Words>285</Words>
  <Application>Microsoft Office PowerPoint</Application>
  <PresentationFormat>Custom</PresentationFormat>
  <Paragraphs>6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linical School Computing Servic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Adkins</dc:creator>
  <cp:lastModifiedBy>Windows User</cp:lastModifiedBy>
  <cp:revision>12</cp:revision>
  <cp:lastPrinted>2019-05-01T07:37:51Z</cp:lastPrinted>
  <dcterms:created xsi:type="dcterms:W3CDTF">2019-02-22T10:17:17Z</dcterms:created>
  <dcterms:modified xsi:type="dcterms:W3CDTF">2019-06-08T17:41:07Z</dcterms:modified>
</cp:coreProperties>
</file>